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721" autoAdjust="0"/>
    <p:restoredTop sz="94694"/>
  </p:normalViewPr>
  <p:slideViewPr>
    <p:cSldViewPr snapToGrid="0">
      <p:cViewPr varScale="1">
        <p:scale>
          <a:sx n="121" d="100"/>
          <a:sy n="121" d="100"/>
        </p:scale>
        <p:origin x="105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EBAED19-719B-41D1-B25B-5833DC1ED2C5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61F0DB6-3B74-4E5F-B971-4F09187E455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625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61F0DB6-3B74-4E5F-B971-4F09187E4551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5980277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7E1803-0057-45BC-A45D-1A70371FA44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AF36CDD-7BCE-4810-BA57-7A30243D74C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8F7B56-4745-4CFA-A520-0324A56AA0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FA5E81-F70C-4F4E-9086-657618A39312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497FB20-6C34-494B-B677-D8A876A47C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7015AB2-4F71-49D3-85AD-7CF9A391EF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F8EAB-12E8-4A33-9348-AB5DF56E52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656067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AC0655-EA9C-4590-8E67-7EFD3F29C5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4B12406-DD7C-428D-8CEE-732C16A2DDB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2BEA45-3D7A-4AB6-8C78-7E8F6C6F8B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FA5E81-F70C-4F4E-9086-657618A39312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4980F2B-A36E-4A83-A3C8-1EBBBE735F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C81C89-52A5-4546-AA0B-0A68B3FF38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F8EAB-12E8-4A33-9348-AB5DF56E52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06231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372CCAD-833F-461E-A33F-3355624C8EC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3184EF8-26BF-497C-BAC9-615B409ADFD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CC6D54D-C061-49E8-AEF6-30F9AE510F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FA5E81-F70C-4F4E-9086-657618A39312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24E52B8-FC54-4DC2-910A-3D01360CDF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60C46B-6742-4F74-A061-7F2D4D611B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F8EAB-12E8-4A33-9348-AB5DF56E52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02447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AC865D-D0A3-49EA-9369-71500AAE67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C8B4710-6704-491D-8207-17440F8AF4D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87E8D5D-0EDA-4067-AF14-AE23449024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FA5E81-F70C-4F4E-9086-657618A39312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ED3FAEB-387C-4457-AF55-C352DB54C3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408F4D-F07C-4942-98C4-B56A60E8A3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F8EAB-12E8-4A33-9348-AB5DF56E52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978613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CA8852-9DE3-404E-BE56-C16CEE767A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D9F9530-04E3-49C7-A144-F195A8D348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01DFBC-7576-4C6E-A844-334003214F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FA5E81-F70C-4F4E-9086-657618A39312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8FF5B2-127E-47E8-B471-05940FA556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ADB33D-2EA1-4A60-84F9-1BA4D285DF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F8EAB-12E8-4A33-9348-AB5DF56E52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39246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CBAE4F-E2CC-414F-AE0D-A16542D158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57237BD-C94D-4C49-BC2E-C897FA64739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14D0304-A136-4125-A104-D2D0996DA67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5D8C5BA-117F-4AB2-A2E0-41DC5302EB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FA5E81-F70C-4F4E-9086-657618A39312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CA7864B-163A-485D-9C30-87D41C6A31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816B952-07B9-4A57-A562-2CCADFC750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F8EAB-12E8-4A33-9348-AB5DF56E52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47584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6FCBAC-5002-49FF-BB4C-9DFE86A880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4E50F4E-FFAC-41FE-8A95-29CF7C043C7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48994F4-55FF-4A77-9276-D03AE90F404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24E1E4D-E96E-41B7-B1BB-929ABA7CF2B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D1EA0D5-BA31-4599-B58E-3EF66FB22B9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C5FD7F4-E966-480F-8277-803378FC28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FA5E81-F70C-4F4E-9086-657618A39312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74719D9-2789-4EAE-BB15-934A4B03F9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B2C0BD9-BD9E-4774-8E25-B3B3F54CA0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F8EAB-12E8-4A33-9348-AB5DF56E52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780381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FBD976-D2B1-4315-B800-5BEF7EAC9D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D7AA4C2-BDEF-4593-B904-94B30222CB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FA5E81-F70C-4F4E-9086-657618A39312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BDE2C20-8410-4BEA-B3A9-E533B7F890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6556DEC-B068-4B38-99A6-C3B0EFF041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F8EAB-12E8-4A33-9348-AB5DF56E52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398217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782EE93-5701-46A0-9AA3-193CF332B6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FA5E81-F70C-4F4E-9086-657618A39312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FFFCE29-7EC0-40D1-B0D3-27B00B024B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80BB3B1-DA03-46B8-AA97-A51B5C438F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F8EAB-12E8-4A33-9348-AB5DF56E52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700560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B78A2A-6BB1-4C14-A470-28AF7122B3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B630819-8368-4B3E-9462-2E2B1968F3C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111996D-B820-459E-97A4-B8D93423883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8D22700-9596-4BBB-8EAA-AA1BEDDB18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FA5E81-F70C-4F4E-9086-657618A39312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B5D3ABF-AB34-40D8-BEAD-C1F0901504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367EFFA-825E-4619-B5F7-803A289BF9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F8EAB-12E8-4A33-9348-AB5DF56E52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587196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39081F-E9B0-40E0-BB8A-44A548ED8E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F5B5326-CAF3-49FB-9E1F-89692E5771C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DCD8DFD-112F-44B5-81DA-E27A86F944D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70E49C4-62AB-450D-9C72-F91B2089B8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FA5E81-F70C-4F4E-9086-657618A39312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D06392A-63E3-46A2-8559-BB45AEE652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F58ADBE-8067-471A-9EA2-C022DE2DF7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F8EAB-12E8-4A33-9348-AB5DF56E52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630892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AB2E193-069F-48D8-A138-D5DB10DF36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1D54499-E8B1-4C63-96C8-EE9B678D3E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4EEDFC5-1F28-4C06-AAE8-073538E993E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FA5E81-F70C-4F4E-9086-657618A39312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50452C-42E2-4DF0-9CBA-EDA18B8BD0B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C89E685-B5DA-4E90-89AE-1516FFAE97A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7F8EAB-12E8-4A33-9348-AB5DF56E52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648560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197AE8-DD78-4C84-895E-9B12982E4834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56238C8-5FE3-4E7C-AF92-747EA676E80A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5E24D43D-5653-4AF1-92BB-D5C4080E57A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8261"/>
          <a:stretch/>
        </p:blipFill>
        <p:spPr>
          <a:xfrm>
            <a:off x="190022" y="842982"/>
            <a:ext cx="11811955" cy="5518111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E54809FC-A1C8-442D-AEC0-553B003C43CE}"/>
              </a:ext>
            </a:extLst>
          </p:cNvPr>
          <p:cNvSpPr/>
          <p:nvPr/>
        </p:nvSpPr>
        <p:spPr>
          <a:xfrm>
            <a:off x="4916166" y="258998"/>
            <a:ext cx="6633409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/>
              <a:t>Supplementary Figure 6:</a:t>
            </a:r>
            <a:r>
              <a:rPr lang="en-US" sz="1400" dirty="0"/>
              <a:t> Dendrogram showing Euclidian distance between lettuce diversity set </a:t>
            </a:r>
            <a:r>
              <a:rPr lang="en-US" sz="1400" dirty="0" err="1"/>
              <a:t>RNAseq</a:t>
            </a:r>
            <a:r>
              <a:rPr lang="en-US" sz="1400" dirty="0"/>
              <a:t> samples. With a few exceptions, biological replicates of the same accession cluster together. </a:t>
            </a:r>
            <a:endParaRPr lang="en-GB" sz="1400" dirty="0"/>
          </a:p>
        </p:txBody>
      </p:sp>
    </p:spTree>
    <p:extLst>
      <p:ext uri="{BB962C8B-B14F-4D97-AF65-F5344CB8AC3E}">
        <p14:creationId xmlns:p14="http://schemas.microsoft.com/office/powerpoint/2010/main" val="35882405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</TotalTime>
  <Words>30</Words>
  <Application>Microsoft Macintosh PowerPoint</Application>
  <PresentationFormat>Widescreen</PresentationFormat>
  <Paragraphs>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rry Pink</dc:creator>
  <cp:lastModifiedBy>Katherine Denby</cp:lastModifiedBy>
  <cp:revision>8</cp:revision>
  <dcterms:created xsi:type="dcterms:W3CDTF">2021-08-26T11:04:44Z</dcterms:created>
  <dcterms:modified xsi:type="dcterms:W3CDTF">2022-02-20T15:38:31Z</dcterms:modified>
</cp:coreProperties>
</file>